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3F116-FC60-4C93-AF9A-9AF4E4DB93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FCA1D-E0B3-463B-B69F-BF6232BF1C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394845-AA79-4CBF-A079-2E46E3C49A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2F9D8-FB5F-42B7-A2BC-0327EAD633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556CC1-3B5B-4C31-AC57-9354983FE9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77E05-7FDB-46A4-8AB8-DF4E102A53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1E9E5-3F60-4C6A-AEF7-03C0C7803C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9EE392-90C1-4C0C-A393-093E2E50AB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085D6-4731-42C8-9182-839609F8C2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A9209-20F9-4995-866D-427D48AFF2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65C9D-D749-4A62-B71C-B1CCAF3A8A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CA905-92A7-4F70-9FD5-81AB459ECC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19E112-2DB2-4013-A912-A8F843C149D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849400" y="4035600"/>
            <a:ext cx="5607360" cy="1443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219240" y="878040"/>
            <a:ext cx="1312560" cy="5252760"/>
          </a:xfrm>
          <a:prstGeom prst="rect">
            <a:avLst/>
          </a:prstGeom>
          <a:ln w="0">
            <a:noFill/>
          </a:ln>
        </p:spPr>
      </p:pic>
      <p:grpSp>
        <p:nvGrpSpPr>
          <p:cNvPr id="43" name=""/>
          <p:cNvGrpSpPr/>
          <p:nvPr/>
        </p:nvGrpSpPr>
        <p:grpSpPr>
          <a:xfrm>
            <a:off x="595080" y="6175440"/>
            <a:ext cx="1056240" cy="230760"/>
            <a:chOff x="595080" y="6175440"/>
            <a:chExt cx="1056240" cy="230760"/>
          </a:xfrm>
        </p:grpSpPr>
        <p:pic>
          <p:nvPicPr>
            <p:cNvPr id="44" name="" descr=""/>
            <p:cNvPicPr/>
            <p:nvPr/>
          </p:nvPicPr>
          <p:blipFill>
            <a:blip r:embed="rId3"/>
            <a:stretch/>
          </p:blipFill>
          <p:spPr>
            <a:xfrm>
              <a:off x="712800" y="6175440"/>
              <a:ext cx="820800" cy="57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"/>
            <p:cNvSpPr/>
            <p:nvPr/>
          </p:nvSpPr>
          <p:spPr>
            <a:xfrm>
              <a:off x="595080" y="6205680"/>
              <a:ext cx="281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&gt;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341000" y="6205680"/>
              <a:ext cx="310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&lt;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004400" y="620568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>
            <a:off x="8464320" y="3276720"/>
            <a:ext cx="390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rad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8467200" y="3649680"/>
            <a:ext cx="4579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RBB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466120" y="3835440"/>
            <a:ext cx="2491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8465760" y="3090960"/>
            <a:ext cx="3117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8466840" y="4022640"/>
            <a:ext cx="279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S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603440" y="3110040"/>
            <a:ext cx="73080" cy="28728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603440" y="3686040"/>
            <a:ext cx="73080" cy="216000"/>
          </a:xfrm>
          <a:prstGeom prst="rect">
            <a:avLst/>
          </a:prstGeom>
          <a:solidFill>
            <a:srgbClr val="00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603440" y="2585880"/>
            <a:ext cx="73080" cy="1796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603440" y="5197320"/>
            <a:ext cx="73080" cy="287640"/>
          </a:xfrm>
          <a:prstGeom prst="rect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603440" y="4487760"/>
            <a:ext cx="73080" cy="360360"/>
          </a:xfrm>
          <a:prstGeom prst="rect">
            <a:avLst/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603440" y="4019400"/>
            <a:ext cx="73080" cy="71640"/>
          </a:xfrm>
          <a:prstGeom prst="rect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746000" y="4576680"/>
            <a:ext cx="339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743840" y="5249880"/>
            <a:ext cx="53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Lumin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744560" y="3944880"/>
            <a:ext cx="502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RBB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743120" y="2573280"/>
            <a:ext cx="816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744560" y="3200400"/>
            <a:ext cx="383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s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744920" y="3692520"/>
            <a:ext cx="552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mmu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" descr=""/>
          <p:cNvPicPr/>
          <p:nvPr/>
        </p:nvPicPr>
        <p:blipFill>
          <a:blip r:embed="rId4"/>
          <a:stretch/>
        </p:blipFill>
        <p:spPr>
          <a:xfrm>
            <a:off x="2849400" y="1654200"/>
            <a:ext cx="5607360" cy="140184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5"/>
          <a:stretch/>
        </p:blipFill>
        <p:spPr>
          <a:xfrm>
            <a:off x="2849400" y="3289320"/>
            <a:ext cx="5605560" cy="14436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6"/>
          <a:stretch/>
        </p:blipFill>
        <p:spPr>
          <a:xfrm>
            <a:off x="2849400" y="3662280"/>
            <a:ext cx="5605560" cy="14472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7"/>
          <a:stretch/>
        </p:blipFill>
        <p:spPr>
          <a:xfrm>
            <a:off x="2849400" y="3848040"/>
            <a:ext cx="5605560" cy="14436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8"/>
          <a:stretch/>
        </p:blipFill>
        <p:spPr>
          <a:xfrm>
            <a:off x="2849400" y="3103560"/>
            <a:ext cx="5605560" cy="144360"/>
          </a:xfrm>
          <a:prstGeom prst="rect">
            <a:avLst/>
          </a:prstGeom>
          <a:ln w="0">
            <a:noFill/>
          </a:ln>
        </p:spPr>
      </p:pic>
      <p:grpSp>
        <p:nvGrpSpPr>
          <p:cNvPr id="70" name=""/>
          <p:cNvGrpSpPr/>
          <p:nvPr/>
        </p:nvGrpSpPr>
        <p:grpSpPr>
          <a:xfrm>
            <a:off x="6062760" y="1477800"/>
            <a:ext cx="1454040" cy="2814840"/>
            <a:chOff x="6062760" y="1477800"/>
            <a:chExt cx="1454040" cy="2814840"/>
          </a:xfrm>
        </p:grpSpPr>
        <p:sp>
          <p:nvSpPr>
            <p:cNvPr id="71" name=""/>
            <p:cNvSpPr/>
            <p:nvPr/>
          </p:nvSpPr>
          <p:spPr>
            <a:xfrm>
              <a:off x="6062760" y="1477800"/>
              <a:ext cx="0" cy="2814840"/>
            </a:xfrm>
            <a:prstGeom prst="line">
              <a:avLst/>
            </a:prstGeom>
            <a:ln w="19080">
              <a:solidFill>
                <a:srgbClr val="ff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516800" y="1477800"/>
              <a:ext cx="0" cy="2814840"/>
            </a:xfrm>
            <a:prstGeom prst="line">
              <a:avLst/>
            </a:prstGeom>
            <a:ln w="19080">
              <a:solidFill>
                <a:srgbClr val="ff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73" name="" descr=""/>
          <p:cNvPicPr/>
          <p:nvPr/>
        </p:nvPicPr>
        <p:blipFill>
          <a:blip r:embed="rId9"/>
          <a:stretch/>
        </p:blipFill>
        <p:spPr>
          <a:xfrm>
            <a:off x="2849400" y="3475080"/>
            <a:ext cx="5604120" cy="14436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8466480" y="3462480"/>
            <a:ext cx="194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360320" y="1798560"/>
            <a:ext cx="997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684120" y="1798560"/>
            <a:ext cx="1987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I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851960" y="1798560"/>
            <a:ext cx="2980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II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33640" y="4968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773440" y="1557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7741800" y="6308640"/>
            <a:ext cx="1119960" cy="34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7920" rIns="97920" tIns="48960" bIns="48960" anchor="t">
            <a:spAutoFit/>
          </a:bodyPr>
          <a:p>
            <a:pPr>
              <a:tabLst>
                <a:tab algn="l" pos="0"/>
                <a:tab algn="l" pos="979560"/>
                <a:tab algn="l" pos="1959120"/>
                <a:tab algn="l" pos="2938320"/>
                <a:tab algn="l" pos="3917880"/>
                <a:tab algn="l" pos="4897440"/>
                <a:tab algn="l" pos="5877000"/>
                <a:tab algn="l" pos="6856560"/>
                <a:tab algn="l" pos="7835760"/>
                <a:tab algn="l" pos="8815320"/>
                <a:tab algn="l" pos="9794880"/>
                <a:tab algn="l" pos="1077444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39400" y="6146640"/>
            <a:ext cx="430560" cy="13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rati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9T14:39:39Z</dcterms:created>
  <dc:creator>FINETTIP</dc:creator>
  <dc:description/>
  <dc:language>en-US</dc:language>
  <cp:lastModifiedBy>FINETTIP</cp:lastModifiedBy>
  <dcterms:modified xsi:type="dcterms:W3CDTF">2010-11-15T16:03:34Z</dcterms:modified>
  <cp:revision>19</cp:revision>
  <dc:subject/>
  <dc:title>Diapositive 1</dc:title>
</cp:coreProperties>
</file>